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639" r:id="rId2"/>
    <p:sldId id="64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7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84AE3-965E-9805-394D-778C89205D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BCF933-870E-8FBA-05DB-68129E3B5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8A4CF3-E332-DBA9-84F6-BCAE54931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D8B0DB-EFB4-8255-B3D0-8CD0FD950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5B18F2-C7C8-BBFE-329B-8E2982A44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872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4A6F1-596C-8658-CDD2-9E9ECBBFC0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AD6225-2D22-A914-BB49-834F25C30F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9B6BA8-BA73-65F8-D849-BDEC252A0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AD288F-ACDB-5021-DDD2-0C2356A51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D30A0E-76BC-4D86-3031-B2726C56F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314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2076F7-C448-9291-A140-2C9451F322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94CE49-246A-5E1E-8E25-6C5B4865C3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752740-7019-2BBD-9320-2FB237EB5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F8287-FE75-2604-DA84-ABA4227E6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2E8A41-0258-9515-BD5A-52271AEAF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803583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4EE502-26F1-4C14-8006-E86D8F1E92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049500F-CC95-49B3-830F-417100FC66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212345" y="1965579"/>
            <a:ext cx="11753977" cy="39060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C95302F-267A-4618-91A0-E4C43D68A43B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cs typeface="Arial"/>
              </a:rPr>
              <a:t>| Optional</a:t>
            </a:r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337AE33-605D-4070-AE5D-63D17AF9551A}"/>
              </a:ext>
            </a:extLst>
          </p:cNvPr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fld id="{368FC967-E25B-4DC7-87C0-1C454DF70C3D}" type="datetime1">
              <a:rPr kumimoji="0" lang="de-DE" sz="9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cs typeface="Arial"/>
              </a:rPr>
              <a:t>20.10.2023</a:t>
            </a:fld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2BBEB6-46D3-4689-9C2A-D1A144321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fld id="{D7C0CCF7-DF53-4ADB-AAD8-9742C01AD446}" type="slidenum">
              <a:rPr kumimoji="0" lang="de-DE" sz="900" b="1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cs typeface="Arial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110"/>
                </a:spcBef>
                <a:spcAft>
                  <a:spcPts val="11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de-DE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19721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53A6E-FEF5-3079-B200-FF0D88B4A8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41C0BD-F592-AEEA-CBE8-2BE0AAA973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DC6FCA-1D73-6D60-EDEE-D46A96879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18D9D0-A334-D70C-3E2E-E435C75C4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04CBD-0C67-345E-C9BF-4F9E36604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718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2F50F0-3C6B-FFDF-0654-6994427875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A07E0C-984B-A2E6-F302-10A7787A6A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BC45E-C94F-0367-C4A6-8856B7852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A110F2-C3E1-43A7-EDA9-5DD4F5F08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6C3C18-04C6-5599-4851-BCC654FDE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759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B2681A-33B7-2D65-9174-6063637BD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4EEF29-6219-9793-4B89-055FAF6F85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D130E5-DD2E-5C95-C445-34CF3C6C10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9FBD47-5150-5ED2-9857-82E839CFA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267B50-4EE5-66EB-F2A4-6AD81A24D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9CE177-A4B0-46CE-E662-BF21695F3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216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5FCA1-F5FB-301A-7FBB-D72474F7C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A6210E-03E7-7558-D3E6-83AF97F506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052171-E361-AA9A-86B9-E861F75261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1792DE-9F3C-CC62-6CEE-8EAF3DB027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6605AE0-7994-65A5-0710-5F16DACF9E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71C2AD-2272-5A75-46CC-9A4313803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13C777-C19D-AD03-8C97-CE4D87516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32B619-AB5E-8F9F-7AB3-D9A0FC79C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554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8D0E3-2BA2-E6B0-8479-002D0F1B0D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AEB4E6-5ACB-9DBC-D421-D6224300D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7876C5-B720-F418-4C68-9FF173C4B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C04713-E975-642B-F604-297978C07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300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5F041E-0D7A-B433-1963-CA5640A0B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D81489-7BF7-03BA-010E-9FE792096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96FE74-44DC-BF05-75CF-B7B6E1CE9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3271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C6FA74-FC83-8BAD-37EF-8BE95A02A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110B76-E3B6-381E-0323-21DEFCAE45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44AF14-6BD9-D570-435B-855193F040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E7DBAA-2038-5839-097B-A711A7EEB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B76E5C-1808-33A9-2633-4CC7FE750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E348FE-27E9-3364-EBC7-DDFAC6868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039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B0157-6B6C-F4BE-8DFB-13E83CB222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762B53-3374-C352-EEDB-201EAF2762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1FE770-7E09-F74E-4944-0A400E9395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2B66-587B-BC75-8C8E-8D3B22958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20603A-69FC-DF53-7B0E-A60709842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603279-B3C1-F29A-90DE-3DCEBB23F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099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B0748A-40A4-F401-01D5-66516B738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A41344-EA87-AEBB-8DD2-8D572E9483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515ED4-83C8-A977-60AE-9359C1D2C2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55AD7-170B-42FF-AC7A-1B7BBB638091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00A238-C50C-A7AF-AB00-C8035977FA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38DE8-1B77-15BA-D9E6-13CA08A074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56FDF-78EF-4FFC-AC1F-5B53FCB592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9125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AB5AB88-8AC6-4D27-9124-3AB6695EE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606425"/>
          </a:xfrm>
        </p:spPr>
        <p:txBody>
          <a:bodyPr>
            <a:normAutofit/>
          </a:bodyPr>
          <a:lstStyle/>
          <a:p>
            <a:r>
              <a:rPr lang="de-DE" sz="3200" dirty="0"/>
              <a:t>Pattern Ranking – Males (</a:t>
            </a:r>
            <a:r>
              <a:rPr lang="de-DE" sz="3200" dirty="0" err="1"/>
              <a:t>Overview</a:t>
            </a:r>
            <a:r>
              <a:rPr lang="de-DE" sz="3200" dirty="0"/>
              <a:t>)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57B42E9-13F8-48B3-B710-674371422611}"/>
              </a:ext>
            </a:extLst>
          </p:cNvPr>
          <p:cNvSpPr>
            <a:spLocks noGrp="1"/>
          </p:cNvSpPr>
          <p:nvPr>
            <p:ph type="dt" sz="half" idx="11"/>
          </p:nvPr>
        </p:nvSpPr>
        <p:spPr>
          <a:xfrm>
            <a:off x="687600" y="6516000"/>
            <a:ext cx="468000" cy="151200"/>
          </a:xfrm>
          <a:prstGeom prst="rect">
            <a:avLst/>
          </a:prstGeom>
        </p:spPr>
        <p:txBody>
          <a:bodyPr vert="horz" wrap="none" lIns="0" tIns="0" rIns="0" bIns="0" rtlCol="0" anchor="t" anchorCtr="0">
            <a:noAutofit/>
          </a:bodyPr>
          <a:lstStyle>
            <a:defPPr lvl="0">
              <a:defRPr lang="de-DE"/>
            </a:defPPr>
            <a:lvl1pPr marL="0" lvl="1" algn="l" defTabSz="914400" rtl="0" eaLnBrk="1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None/>
              <a:defRPr sz="9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A96B4F9-E80C-4283-96EA-8D9B637CC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226800" y="6516000"/>
            <a:ext cx="360000" cy="151200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defPPr lvl="0">
              <a:defRPr lang="de-DE"/>
            </a:defPPr>
            <a:lvl1pPr marL="0" lvl="1" algn="l" defTabSz="914400" rtl="0" eaLnBrk="1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None/>
              <a:defRPr sz="900" b="1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fld id="{D7C0CCF7-DF53-4ADB-AAD8-9742C01AD446}" type="slidenum">
              <a:rPr lang="de-DE" smtClean="0">
                <a:solidFill>
                  <a:srgbClr val="000000"/>
                </a:solidFill>
                <a:latin typeface="Arial" panose="020B0604020202020204"/>
                <a:cs typeface="Arial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110"/>
                </a:spcBef>
                <a:spcAft>
                  <a:spcPts val="11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de-DE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94F800CB-4E98-44FE-BF72-1DBB498253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01100" y="308553"/>
            <a:ext cx="1354500" cy="720533"/>
          </a:xfrm>
          <a:prstGeom prst="rect">
            <a:avLst/>
          </a:prstGeom>
        </p:spPr>
      </p:pic>
      <p:sp>
        <p:nvSpPr>
          <p:cNvPr id="18" name="Rechteck 17">
            <a:extLst>
              <a:ext uri="{FF2B5EF4-FFF2-40B4-BE49-F238E27FC236}">
                <a16:creationId xmlns:a16="http://schemas.microsoft.com/office/drawing/2014/main" id="{8E2FDD3E-5663-4F49-8EDA-F9620AEFB733}"/>
              </a:ext>
            </a:extLst>
          </p:cNvPr>
          <p:cNvSpPr/>
          <p:nvPr/>
        </p:nvSpPr>
        <p:spPr>
          <a:xfrm>
            <a:off x="1376128" y="1065009"/>
            <a:ext cx="3920150" cy="301669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/>
              <a:t>Marker Compounds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B06DA6F2-A713-4F91-BD5B-51CBDE7EE1C5}"/>
              </a:ext>
            </a:extLst>
          </p:cNvPr>
          <p:cNvSpPr/>
          <p:nvPr/>
        </p:nvSpPr>
        <p:spPr>
          <a:xfrm>
            <a:off x="5314383" y="1061100"/>
            <a:ext cx="1276539" cy="301669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/>
              <a:t>BASF LOA Streams</a:t>
            </a: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F79A8DAF-5C58-4A18-8D3D-C784CD93B47E}"/>
              </a:ext>
            </a:extLst>
          </p:cNvPr>
          <p:cNvSpPr/>
          <p:nvPr/>
        </p:nvSpPr>
        <p:spPr>
          <a:xfrm>
            <a:off x="6609027" y="1070152"/>
            <a:ext cx="5252023" cy="301669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/>
              <a:t>LOA Streams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1ED67C62-59D2-4631-B932-EF4A52A34D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787" y="1376036"/>
            <a:ext cx="11641175" cy="46774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9516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AB5AB88-8AC6-4D27-9124-3AB6695EE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663961"/>
          </a:xfrm>
        </p:spPr>
        <p:txBody>
          <a:bodyPr>
            <a:normAutofit/>
          </a:bodyPr>
          <a:lstStyle/>
          <a:p>
            <a:r>
              <a:rPr lang="de-DE" sz="3200" dirty="0"/>
              <a:t>Pattern Ranking – </a:t>
            </a:r>
            <a:r>
              <a:rPr lang="de-DE" sz="3200" dirty="0" err="1"/>
              <a:t>Females</a:t>
            </a:r>
            <a:r>
              <a:rPr lang="de-DE" sz="3200" dirty="0"/>
              <a:t> (</a:t>
            </a:r>
            <a:r>
              <a:rPr lang="de-DE" sz="3200" dirty="0" err="1"/>
              <a:t>Overview</a:t>
            </a:r>
            <a:r>
              <a:rPr lang="de-DE" sz="3200" dirty="0"/>
              <a:t>)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57B42E9-13F8-48B3-B710-674371422611}"/>
              </a:ext>
            </a:extLst>
          </p:cNvPr>
          <p:cNvSpPr>
            <a:spLocks noGrp="1"/>
          </p:cNvSpPr>
          <p:nvPr>
            <p:ph type="dt" sz="half" idx="11"/>
          </p:nvPr>
        </p:nvSpPr>
        <p:spPr>
          <a:xfrm>
            <a:off x="687600" y="6516000"/>
            <a:ext cx="468000" cy="151200"/>
          </a:xfrm>
          <a:prstGeom prst="rect">
            <a:avLst/>
          </a:prstGeom>
        </p:spPr>
        <p:txBody>
          <a:bodyPr vert="horz" wrap="none" lIns="0" tIns="0" rIns="0" bIns="0" rtlCol="0" anchor="t" anchorCtr="0">
            <a:noAutofit/>
          </a:bodyPr>
          <a:lstStyle>
            <a:defPPr lvl="0">
              <a:defRPr lang="de-DE"/>
            </a:defPPr>
            <a:lvl1pPr marL="0" lvl="1" algn="l" defTabSz="914400" rtl="0" eaLnBrk="1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None/>
              <a:defRPr sz="900" b="0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A96B4F9-E80C-4283-96EA-8D9B637CC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226800" y="6516000"/>
            <a:ext cx="360000" cy="151200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defPPr lvl="0">
              <a:defRPr lang="de-DE"/>
            </a:defPPr>
            <a:lvl1pPr marL="0" lvl="1" algn="l" defTabSz="914400" rtl="0" eaLnBrk="1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None/>
              <a:defRPr sz="900" b="1" i="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110"/>
              </a:spcBef>
              <a:spcAft>
                <a:spcPts val="110"/>
              </a:spcAft>
              <a:buClrTx/>
              <a:buSzTx/>
              <a:buFontTx/>
              <a:buNone/>
              <a:tabLst/>
              <a:defRPr/>
            </a:pPr>
            <a:fld id="{D7C0CCF7-DF53-4ADB-AAD8-9742C01AD446}" type="slidenum">
              <a:rPr lang="de-DE" smtClean="0">
                <a:solidFill>
                  <a:srgbClr val="000000"/>
                </a:solidFill>
                <a:latin typeface="Arial" panose="020B0604020202020204"/>
                <a:cs typeface="Arial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110"/>
                </a:spcBef>
                <a:spcAft>
                  <a:spcPts val="11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de-DE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/>
              <a:cs typeface="Arial"/>
            </a:endParaRP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94F800CB-4E98-44FE-BF72-1DBB498253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01100" y="308553"/>
            <a:ext cx="1354500" cy="720533"/>
          </a:xfrm>
          <a:prstGeom prst="rect">
            <a:avLst/>
          </a:prstGeom>
        </p:spPr>
      </p:pic>
      <p:sp>
        <p:nvSpPr>
          <p:cNvPr id="18" name="Rechteck 17">
            <a:extLst>
              <a:ext uri="{FF2B5EF4-FFF2-40B4-BE49-F238E27FC236}">
                <a16:creationId xmlns:a16="http://schemas.microsoft.com/office/drawing/2014/main" id="{8E2FDD3E-5663-4F49-8EDA-F9620AEFB733}"/>
              </a:ext>
            </a:extLst>
          </p:cNvPr>
          <p:cNvSpPr/>
          <p:nvPr/>
        </p:nvSpPr>
        <p:spPr>
          <a:xfrm>
            <a:off x="1376128" y="1065009"/>
            <a:ext cx="3920150" cy="301669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/>
              <a:t>Marker Compounds</a:t>
            </a:r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B06DA6F2-A713-4F91-BD5B-51CBDE7EE1C5}"/>
              </a:ext>
            </a:extLst>
          </p:cNvPr>
          <p:cNvSpPr/>
          <p:nvPr/>
        </p:nvSpPr>
        <p:spPr>
          <a:xfrm>
            <a:off x="5314383" y="1061100"/>
            <a:ext cx="1276539" cy="301669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/>
              <a:t>BASF LOA Streams</a:t>
            </a: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F79A8DAF-5C58-4A18-8D3D-C784CD93B47E}"/>
              </a:ext>
            </a:extLst>
          </p:cNvPr>
          <p:cNvSpPr/>
          <p:nvPr/>
        </p:nvSpPr>
        <p:spPr>
          <a:xfrm>
            <a:off x="6609027" y="1070152"/>
            <a:ext cx="5252023" cy="301669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/>
              <a:t>LOA Streams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D8906BBA-7231-4426-9FE8-45416339A6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551" y="1376033"/>
            <a:ext cx="11631648" cy="4715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6075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attern Ranking – Males (Overview)</vt:lpstr>
      <vt:lpstr>Pattern Ranking – Females (Overview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ttern Ranking – Males (Overview)</dc:title>
  <dc:creator>Bennard van Ravenzwaay</dc:creator>
  <cp:lastModifiedBy>Bennard van Ravenzwaay</cp:lastModifiedBy>
  <cp:revision>1</cp:revision>
  <dcterms:created xsi:type="dcterms:W3CDTF">2023-10-20T15:40:51Z</dcterms:created>
  <dcterms:modified xsi:type="dcterms:W3CDTF">2023-10-20T15:43:45Z</dcterms:modified>
</cp:coreProperties>
</file>